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1B1F2D-8C48-4D07-B008-8FF21ABEECD9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C985F79-1B5D-459E-B79C-05A595F43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478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853AB-ED5D-43A6-9321-AC20D3EBA6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06FF73-F942-4B35-B4EE-5AACE73CB3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8B8631-33FF-4F5B-80BA-C3E8D926B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C8F398-0C74-4F7C-B1BB-515D67886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EB5E59-9890-476B-9A84-37DC29A12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571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8D511-2D5E-4AF5-BD52-711BDE882D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DA455E-49D9-4709-826A-38CD42E93A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C82938-D809-467F-8A85-683A38122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A8E923-4D00-45FF-AEC1-FDA3E5C4C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880B7E-E1D3-42C8-81D6-3332DEBDF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576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D4B211-C767-448F-BC74-404B1F2BE3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74966F-4BE5-4CC5-98E5-35BA4321D5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E8A0D4-95FF-4DA5-9970-FF4067AA4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9CB87-2AD7-4648-AC31-66A18F269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FABAEE-0DC3-4399-A704-D253F49F5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011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4C213-8DDC-4624-9451-F95CD7699D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C91F5A-D905-43D5-A098-88A399F470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C64E7-71EE-4902-A7B5-1CD00E2A6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21A4A-74CE-42B2-8B07-C76D31AD8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BA6F13-8AA0-4075-A023-BB65C90D8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618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32955E-ACDC-468E-9798-B83F94A44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AB0827-CAF4-42A8-B5BF-C918B6B69F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FAC7E7-133A-4BB9-BDB0-C6AC62B10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70FDF0-CD66-4FF9-82E7-F91C1CCAD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878981-9882-4511-A38C-C5FB09FBA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089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54B001-1D28-4E11-BA33-C85B71811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2380C1-19D7-4195-A1D2-8AD2AE84A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606348-A1E9-46E7-8A8F-465DE38B6C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6D4534-C27F-4177-8275-C06A42093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B923B65-FA67-4AD8-8BEC-F3F4D96CF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9BF6C7-BA36-4DEA-83EC-48DBD1F2B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472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4E440B-5165-42ED-81F2-DCAB3BB417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44D15C-2052-483F-BD1B-6125B07372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CBA87D-652A-4F03-B5DB-43FED585AB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BD1C10-FC3D-4AE4-AB58-D5F4C51E850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21C231-69EA-4502-AA30-47932171E7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5AC0A5-4FA8-4502-8512-0B5D34877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7F23B5E-9DF8-449A-B201-A12F3C5954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F47940-45DC-4DEC-A993-80164C51C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243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2E0F22-2376-43DB-8FC4-1C700EC99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4EB755-0C4D-4034-8544-30DE6B4B3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CC76C8-71BD-440E-9417-F08AAC5C3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C97AA8-C690-4EF4-901E-C0A203B69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588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DA7A9D7-950D-4ADC-B430-FA918821A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5B0D29-6488-4601-8872-452A3A3D1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9DDECD-7FE0-4CCA-84A1-6A4E7978A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61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D3D22D-E22B-46CB-B2F6-0538D91771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F7B522-5BD9-48CA-9DB6-EE6AF4B7B7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057190-DA7D-4DD1-B8A8-A09DB044AD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01199E-83B4-456A-BE74-3CE125C22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3B3951-0855-4ACE-92C6-D84777B7C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77E579-175C-4259-892F-8F77CCC94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342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B2B1B-C6BE-4CFB-B707-A18F5F692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AC81A3-1DDC-4CF6-B913-A7145FB670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39E0E0-51AC-46C7-92A5-1F46664B81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E064F8-B31B-484B-9D32-08E44B4CE7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E49C02-5229-4936-953E-6EDB0DF8D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6733BC-3E29-4E63-8FE9-589552DE6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42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5DE8F33-1C42-4FA5-8689-D2E21D2A0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6BB3EC-70F9-429E-A8BB-5E2DDF9EF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98DBA7-20CC-4246-9D56-8A7F3BD77B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95932-3335-41C9-9830-067AFAA565B5}" type="datetimeFigureOut">
              <a:rPr lang="en-US" smtClean="0"/>
              <a:t>4/2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60B9F3-9DC3-472C-A9F7-609AA63860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4C8999-1ED4-4C13-BB63-76400EE2F7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1254DF-60C4-454F-A2FE-CBE5E9B15F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401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oogle Shape;102;gb973b1da94_0_0">
            <a:extLst>
              <a:ext uri="{FF2B5EF4-FFF2-40B4-BE49-F238E27FC236}">
                <a16:creationId xmlns:a16="http://schemas.microsoft.com/office/drawing/2014/main" id="{4F49D454-E39C-4F2D-8011-DB0A741FF77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48721337"/>
              </p:ext>
            </p:extLst>
          </p:nvPr>
        </p:nvGraphicFramePr>
        <p:xfrm>
          <a:off x="360728" y="432650"/>
          <a:ext cx="11274799" cy="5992700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144543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49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7495">
                  <a:extLst>
                    <a:ext uri="{9D8B030D-6E8A-4147-A177-3AD203B41FA5}">
                      <a16:colId xmlns:a16="http://schemas.microsoft.com/office/drawing/2014/main" val="4213848282"/>
                    </a:ext>
                  </a:extLst>
                </a:gridCol>
                <a:gridCol w="7674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749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257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0919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5165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8334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6749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6749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4898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4898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4898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280134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Our Study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Du K                     2021 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Liu L 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020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ao HC          2019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Low SC          2019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uan Z </a:t>
                      </a:r>
                      <a:endParaRPr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019</a:t>
                      </a:r>
                      <a:endParaRPr sz="1000" u="none" strike="noStrike" cap="none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en Q</a:t>
                      </a:r>
                      <a:endParaRPr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018</a:t>
                      </a:r>
                      <a:endParaRPr sz="1000" u="none" strike="noStrike" cap="none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Hsu HC</a:t>
                      </a:r>
                      <a:endParaRPr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2017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ao CC     2015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ang NCC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010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Liu YT </a:t>
                      </a:r>
                      <a:endParaRPr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008</a:t>
                      </a:r>
                      <a:endParaRPr sz="1000" u="none" strike="noStrike" cap="none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Lacann HJ 2000</a:t>
                      </a:r>
                      <a:endParaRPr sz="1000" u="none" strike="noStrike" cap="none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chibana N 1999</a:t>
                      </a:r>
                      <a:endParaRPr sz="1000" u="none" strike="noStrike" cap="none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accent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423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Ethnicity</a:t>
                      </a:r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Number of</a:t>
                      </a:r>
                      <a:r>
                        <a:rPr lang="en-US" sz="1000" b="0" i="0" u="none" strike="noStrike" cap="none" baseline="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patients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rgbClr val="B3C6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hai-Chinese 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inese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inese</a:t>
                      </a:r>
                      <a:endParaRPr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</a:t>
                      </a:r>
                      <a:endParaRPr sz="1000" u="none" strike="noStrike" cap="none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Han-Taiwanese 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3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inese-</a:t>
                      </a:r>
                      <a:r>
                        <a:rPr lang="en-US" sz="1000" u="none" strike="noStrike" cap="none" baseline="0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</a:t>
                      </a: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Malaysian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inese 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</a:t>
                      </a:r>
                      <a:r>
                        <a:rPr lang="en-US" sz="1000" u="none" strike="noStrike" cap="none" baseline="30000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a</a:t>
                      </a: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hinese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iwanese   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7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iwanese  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8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iwanese </a:t>
                      </a:r>
                      <a:endParaRPr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9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iwanese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iwanese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Taiwanese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34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 Age of onset (years) 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rgbClr val="B3C6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48.3 (32-60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8.6 (54-65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4.8 (23-80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8.3(SD 7.4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9.1 (49-66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38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8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1.7 (55-69)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9.9 (48-71)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9.5 (48-68)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1.2              (47-60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8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8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450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Sex  M : F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rgbClr val="B3C6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 : 4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 : 0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3 : 2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 : 3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 : 0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 : 0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5 : 2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25 : 3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6 : 3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3 : 2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 : 0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 : 0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7822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Symmetrical polyneuropathy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rgbClr val="C4E0B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/9 (10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/9 (10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7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 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28/28 (10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9/19                 (10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/5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0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b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762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Neuropathic  </a:t>
                      </a:r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involvement during </a:t>
                      </a:r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follow-up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rgbClr val="C4E0B2"/>
                    </a:solidFill>
                  </a:tcPr>
                </a:tc>
                <a:tc gridSpan="13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hMerge="1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400" b="0" i="0" u="none" strike="noStrike" cap="none" dirty="0">
                        <a:solidFill>
                          <a:srgbClr val="000000"/>
                        </a:solidFill>
                        <a:latin typeface="CordiaUPC"/>
                        <a:ea typeface="CordiaUPC"/>
                        <a:cs typeface="CordiaUPC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82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Sensory</a:t>
                      </a:r>
                      <a:endParaRPr sz="1000" b="0" i="0" u="none" strike="noStrike" cap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/9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4/5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8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rowSpan="2"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59/73 (80.8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</a:t>
                      </a:r>
                      <a:endParaRPr sz="1000" u="none" strike="noStrike" cap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/9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</a:t>
                      </a:r>
                      <a:endParaRPr sz="1000" b="0" i="0" u="none" strike="noStrike" cap="none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0/1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 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8/28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9/19 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/5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162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Motor</a:t>
                      </a:r>
                      <a:endParaRPr sz="1000" b="0" i="0" u="none" strike="noStrike" cap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/9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55.6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85.7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/5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 vMerge="1">
                  <a:txBody>
                    <a:bodyPr/>
                    <a:lstStyle/>
                    <a:p>
                      <a:endParaRPr lang="th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/9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</a:t>
                      </a:r>
                      <a:endParaRPr sz="1000" b="0" i="0" u="none" strike="noStrike" cap="none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85.7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28/28 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9/19 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/5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874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Autonomic</a:t>
                      </a:r>
                      <a:endParaRPr sz="1000" b="0" i="0" u="none" strike="noStrike" cap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9/9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4/5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0/73                (68.5 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4/4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d</a:t>
                      </a:r>
                      <a:endParaRPr sz="1000" b="0" i="0" u="none" strike="noStrike" cap="none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/7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 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28/28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f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9/19  (10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5/5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100%) 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5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arpal tunnel syndrome</a:t>
                      </a:r>
                      <a:endParaRPr sz="1000" b="0" i="0" u="none" strike="noStrike" cap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/9 (77.8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4/7 (57.1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1/9 (11.1%)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3/7 (42.9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4/5 (8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Progression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 to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decades, 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Faster progression in years after motor involvement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Decade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, </a:t>
                      </a: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(May have rapid deterioration within weeks)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lang="en-US"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 to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decade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Years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u="none" strike="noStrike" cap="none" dirty="0"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0567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Cardiopathy</a:t>
                      </a:r>
                    </a:p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6/9 (66.7%)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4/7 (57.1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/5 (4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HF 16.4%, Arrhythmia 15.1%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highlight>
                          <a:srgbClr val="FFFF00"/>
                        </a:highlight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/9 (55.6%)</a:t>
                      </a: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e </a:t>
                      </a:r>
                      <a:endParaRPr lang="en-US" sz="1000" b="0" i="0" u="none" strike="noStrike" cap="none" baseline="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 </a:t>
                      </a:r>
                      <a:endParaRPr sz="1000" b="0" i="0" u="none" strike="noStrike" cap="none" baseline="300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0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7/7 (10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3/5 (60%)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1/1</a:t>
                      </a:r>
                    </a:p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034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 Weight reduction</a:t>
                      </a:r>
                      <a:endParaRPr sz="1000" u="none" strike="noStrike" cap="none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5" marR="7625" marT="7625" marB="0" anchor="b"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5/9 (55.6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3/7 (42.9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 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2/5 (40%)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0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3425">
                <a:tc>
                  <a:txBody>
                    <a:bodyPr/>
                    <a:lstStyle/>
                    <a:p>
                      <a:pPr marL="0" marR="0" lvl="0" indent="0" algn="l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ther manifestations</a:t>
                      </a:r>
                      <a:endParaRPr sz="1000" u="none" strike="noStrike" cap="non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5" marR="7625" marT="7625" marB="0" anchor="b">
                    <a:solidFill>
                      <a:srgbClr val="C9C9C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one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ough 4/7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one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one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Cough 1/1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one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Glaucoma 1/7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A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Renal 1/5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Renal 1/1</a:t>
                      </a:r>
                      <a:endParaRPr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5" marR="7625" marT="7625" marB="0" anchor="b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600"/>
                        <a:buFont typeface="Arial"/>
                        <a:buNone/>
                      </a:pPr>
                      <a:r>
                        <a:rPr lang="en-US" sz="1000" b="0" i="0" u="none" strike="noStrike" cap="none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CordiaUPC"/>
                          <a:cs typeface="Arial" panose="020B0604020202020204" pitchFamily="34" charset="0"/>
                          <a:sym typeface="CordiaUPC"/>
                        </a:rPr>
                        <a:t>None</a:t>
                      </a:r>
                      <a:endParaRPr sz="1000" b="0" i="0" u="none" strike="noStrike" cap="none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CordiaUPC"/>
                        <a:cs typeface="Arial" panose="020B0604020202020204" pitchFamily="34" charset="0"/>
                        <a:sym typeface="CordiaUPC"/>
                      </a:endParaRPr>
                    </a:p>
                  </a:txBody>
                  <a:tcPr marL="7625" marR="7625" marT="76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29A97EE-B378-4919-88B9-779B1A37D3C6}"/>
              </a:ext>
            </a:extLst>
          </p:cNvPr>
          <p:cNvSpPr txBox="1"/>
          <p:nvPr/>
        </p:nvSpPr>
        <p:spPr>
          <a:xfrm>
            <a:off x="-54766" y="6488668"/>
            <a:ext cx="123250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14300">
              <a:lnSpc>
                <a:spcPct val="90000"/>
              </a:lnSpc>
              <a:spcBef>
                <a:spcPts val="1000"/>
              </a:spcBef>
              <a:buSzPts val="1800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D standard deviation, NA non applicable,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linical data is available for one patient,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lectrodiagnostic study showed sensorimotor polyradiculopathy,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y electrodiagnosis,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d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y autonomic function test,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y echocardiogram, 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by pathological study of sudomotor innervation (autonomic symptoms in 22/28 (78.6%), Possible patient overlap in the studies of Chao CC (2015) and Yang NCC (2010)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FEB7D5-2800-4DF1-8331-452DE3C45F97}"/>
              </a:ext>
            </a:extLst>
          </p:cNvPr>
          <p:cNvSpPr txBox="1"/>
          <p:nvPr/>
        </p:nvSpPr>
        <p:spPr>
          <a:xfrm>
            <a:off x="64894" y="24696"/>
            <a:ext cx="11866465" cy="4247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14300">
              <a:lnSpc>
                <a:spcPct val="90000"/>
              </a:lnSpc>
              <a:spcBef>
                <a:spcPts val="1000"/>
              </a:spcBef>
              <a:buSzPts val="1800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ditional file 2. Table compared epidemiologic data and clinical features of symptomatic ATTRA97S-PN.  Data was derived from literature, published in English (excluding reports without clinical data).  </a:t>
            </a:r>
          </a:p>
        </p:txBody>
      </p:sp>
    </p:spTree>
    <p:extLst>
      <p:ext uri="{BB962C8B-B14F-4D97-AF65-F5344CB8AC3E}">
        <p14:creationId xmlns:p14="http://schemas.microsoft.com/office/powerpoint/2010/main" val="2670996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629</Words>
  <Application>Microsoft Office PowerPoint</Application>
  <PresentationFormat>แบบจอกว้าง</PresentationFormat>
  <Paragraphs>283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3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งานนำเสนอ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h Pasutharnchat</dc:creator>
  <cp:lastModifiedBy>Tanason</cp:lastModifiedBy>
  <cp:revision>7</cp:revision>
  <dcterms:created xsi:type="dcterms:W3CDTF">2021-04-01T09:23:47Z</dcterms:created>
  <dcterms:modified xsi:type="dcterms:W3CDTF">2021-04-29T04:02:57Z</dcterms:modified>
</cp:coreProperties>
</file>